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3"/>
    <p:restoredTop sz="94648"/>
  </p:normalViewPr>
  <p:slideViewPr>
    <p:cSldViewPr snapToGrid="0">
      <p:cViewPr>
        <p:scale>
          <a:sx n="150" d="100"/>
          <a:sy n="150" d="100"/>
        </p:scale>
        <p:origin x="-1206" y="-9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FCA3C9-F836-BC1D-43B2-731496238D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B59361-B843-DD24-B32D-2A600B8EB6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C1A787-FCC4-6CCD-3823-A78C7F8A40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40BE-E51B-BA45-8A99-A27126014CFB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FE79B1-2C03-614B-4C29-92482F7DA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A666F7-3E20-069E-C3D0-72A916B4C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A9E4-BFED-0245-85B9-70F7AD288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764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19AB6C-1ACB-CC12-23C6-65D0453573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9AAEA17-6C22-6CB8-5F8B-DFF7F7D739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6B780E-BCD6-39BF-F885-563A9B2ACD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40BE-E51B-BA45-8A99-A27126014CFB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C486F6-EBE2-DCBB-8EDE-44CED2A3CD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90DA0B-F9AB-B600-8F27-8E58C696A2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A9E4-BFED-0245-85B9-70F7AD288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731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0384F86-C608-4C91-69BA-A13CB9E345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38BDFF-25F4-8A7A-DE4A-030D09DF98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D0F5BA-143C-BF1B-0E9F-95DBCA734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40BE-E51B-BA45-8A99-A27126014CFB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D27501-1844-DAD2-B274-F776F9B3A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1A9341-E53F-2FFE-0DF4-922C46178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A9E4-BFED-0245-85B9-70F7AD288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506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360C27-5F5A-B6B6-5115-A053F25B42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7AB09F-14D1-364D-02A9-A17DF91471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FF4030-BD82-39FB-8CB2-0CEF26787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40BE-E51B-BA45-8A99-A27126014CFB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38D6DB-12E8-EADA-0D06-8D5F723A5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5BA4DF-F708-43E5-3260-748C40A09B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A9E4-BFED-0245-85B9-70F7AD288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65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53176A-478B-3833-5B51-305FF91FDD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8FBB25-D25B-5541-C9DC-8BDAA9FF9D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5D3AE9-741C-AB14-653E-F523E6241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40BE-E51B-BA45-8A99-A27126014CFB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8040E5-5E2B-55CE-8587-93F79B925D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1B481D-CE98-9572-DB53-72D71A5D6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A9E4-BFED-0245-85B9-70F7AD288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012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BB7817-3481-F89C-3115-98471C22FB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95328E-10A1-1E8E-301D-8832D25DE6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3CEDD1-4F32-6DF0-F5AB-452605A0F6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9C19E6-2043-26E0-2FAB-F4326E2C1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40BE-E51B-BA45-8A99-A27126014CFB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E57933-90EF-B8D1-DA6C-738F885E69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D86A36-7928-5FA4-7341-0997F2FF2D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A9E4-BFED-0245-85B9-70F7AD288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405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70AD94-E241-C213-5B92-F52F2C19E3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DD1664-FFC4-E4C8-4D6A-A34BD92892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05DA2F-3589-D3D1-4930-607B30DF4F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91FB4BE-BE07-AA20-AA5F-D479B7FAEA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368B49D-65A2-F906-9C71-34CC40478B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382AB60-33CF-4D83-ABA2-A4117CC71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40BE-E51B-BA45-8A99-A27126014CFB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4B7BD4-6EAC-BA31-8461-B0B0382E5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335240-D744-F748-D786-62F6A84B95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A9E4-BFED-0245-85B9-70F7AD288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584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FFEE43-C1B0-1689-DE71-C5DE2DD413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74B2319-4FB0-C3F3-AD5B-1C711C801E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40BE-E51B-BA45-8A99-A27126014CFB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EB59C9-08E9-B5A2-2B63-DA7734305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C0B3081-ADA7-2EAA-27EB-AAEFE27DF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A9E4-BFED-0245-85B9-70F7AD288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07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6EE225E-8C48-9B8E-E455-C37F1916A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40BE-E51B-BA45-8A99-A27126014CFB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799459D-245E-D09F-3208-9188E40AA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9E9745-DB48-810F-DC35-F1E8510507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A9E4-BFED-0245-85B9-70F7AD288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831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D3209-C8B7-340C-4BC8-34AF9D4943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601752-43BF-077E-015D-C09B9FDBAB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C11F49-0EF6-68D6-8FF0-8C98B36FAB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FD7220-2790-3E83-5E47-C32DD1805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40BE-E51B-BA45-8A99-A27126014CFB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1D601C-F6A1-B516-3AA5-AB44B2F28E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FC3D01-3A6E-3BF5-4342-42A2FAF60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A9E4-BFED-0245-85B9-70F7AD288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092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72A932-29DC-E528-76AE-CDFC3853DE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15AAC5-B9B4-0B10-DB07-7D7B56CC77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1A5277-91EB-D9CC-AC0C-C7FBC3456E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FDAAAB-0497-104C-98FF-DB9407592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E40BE-E51B-BA45-8A99-A27126014CFB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983E27-C08F-7ED2-BC43-39EB8AB4C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59AE53-290D-AFE1-DC32-B80A6EA17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6DA9E4-BFED-0245-85B9-70F7AD288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405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A4091EB-A488-6C4E-D6A6-57E50F2AFB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2E2232-5B9D-63FD-3B8B-0F68438731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EF3F02-CA94-58E5-DCDE-73D3CE3260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D8E40BE-E51B-BA45-8A99-A27126014CFB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218E68-84C7-4030-3A0B-C31BE75B10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7D3154-E142-E23A-B09B-04945E25CA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6DA9E4-BFED-0245-85B9-70F7AD288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845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3BE92BA1-FC5A-C974-4B29-A21DABF719C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14170"/>
              </p:ext>
            </p:extLst>
          </p:nvPr>
        </p:nvGraphicFramePr>
        <p:xfrm>
          <a:off x="2316693" y="1388533"/>
          <a:ext cx="7569043" cy="2674620"/>
        </p:xfrm>
        <a:graphic>
          <a:graphicData uri="http://schemas.openxmlformats.org/drawingml/2006/table">
            <a:tbl>
              <a:tblPr bandRow="1">
                <a:tableStyleId>{9D7B26C5-4107-4FEC-AEDC-1716B250A1EF}</a:tableStyleId>
              </a:tblPr>
              <a:tblGrid>
                <a:gridCol w="4653938">
                  <a:extLst>
                    <a:ext uri="{9D8B030D-6E8A-4147-A177-3AD203B41FA5}">
                      <a16:colId xmlns:a16="http://schemas.microsoft.com/office/drawing/2014/main" val="3132164532"/>
                    </a:ext>
                  </a:extLst>
                </a:gridCol>
                <a:gridCol w="2915105">
                  <a:extLst>
                    <a:ext uri="{9D8B030D-6E8A-4147-A177-3AD203B41FA5}">
                      <a16:colId xmlns:a16="http://schemas.microsoft.com/office/drawing/2014/main" val="4237250190"/>
                    </a:ext>
                  </a:extLst>
                </a:gridCol>
              </a:tblGrid>
              <a:tr h="266700">
                <a:tc gridSpan="2">
                  <a:txBody>
                    <a:bodyPr/>
                    <a:lstStyle/>
                    <a:p>
                      <a:pPr rtl="0" fontAlgn="base"/>
                      <a:r>
                        <a:rPr lang="en-US" sz="1100" b="1" dirty="0">
                          <a:effectLst/>
                        </a:rPr>
                        <a:t>Supplemental Table S1:</a:t>
                      </a:r>
                      <a:r>
                        <a:rPr lang="en-US" sz="1100" b="0" dirty="0">
                          <a:effectLst/>
                        </a:rPr>
                        <a:t>   Definition of irAE type by organ system</a:t>
                      </a:r>
                    </a:p>
                  </a:txBody>
                  <a:tcPr marL="0" marR="0" marT="0" marB="0" anchor="ctr"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extLst>
                  <a:ext uri="{0D108BD9-81ED-4DB2-BD59-A6C34878D82A}">
                    <a16:rowId xmlns:a16="http://schemas.microsoft.com/office/drawing/2014/main" val="1597981270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</a:rPr>
                        <a:t>irAE organ systems assessed</a:t>
                      </a:r>
                    </a:p>
                  </a:txBody>
                  <a:tcPr marL="66675" marR="66675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</a:rPr>
                        <a:t>Examples of irAEs included</a:t>
                      </a:r>
                    </a:p>
                  </a:txBody>
                  <a:tcPr marL="66675" marR="66675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8920138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dirty="0">
                          <a:effectLst/>
                        </a:rPr>
                        <a:t>Gastrointestinal/Hepatic (GI/HEP)</a:t>
                      </a:r>
                    </a:p>
                  </a:txBody>
                  <a:tcPr marL="66674" marR="66674" anchor="ctr">
                    <a:lnT w="12700">
                      <a:solidFill>
                        <a:schemeClr val="tx1"/>
                      </a:solidFill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dirty="0">
                          <a:effectLst/>
                        </a:rPr>
                        <a:t>Colitis, LFT elevation</a:t>
                      </a:r>
                    </a:p>
                  </a:txBody>
                  <a:tcPr marL="66674" marR="66674">
                    <a:lnT w="12700">
                      <a:solidFill>
                        <a:schemeClr val="tx1"/>
                      </a:solidFill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9523486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dirty="0">
                          <a:effectLst/>
                        </a:rPr>
                        <a:t>Dermatologic (DERM)</a:t>
                      </a:r>
                    </a:p>
                  </a:txBody>
                  <a:tcPr marL="66675" marR="66675"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</a:rPr>
                        <a:t>Rash</a:t>
                      </a:r>
                    </a:p>
                  </a:txBody>
                  <a:tcPr marL="66675" marR="66675"/>
                </a:tc>
                <a:extLst>
                  <a:ext uri="{0D108BD9-81ED-4DB2-BD59-A6C34878D82A}">
                    <a16:rowId xmlns:a16="http://schemas.microsoft.com/office/drawing/2014/main" val="338009236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dirty="0">
                          <a:effectLst/>
                        </a:rPr>
                        <a:t>Endocrine (ENDO)</a:t>
                      </a:r>
                    </a:p>
                  </a:txBody>
                  <a:tcPr marL="66675" marR="66675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</a:rPr>
                        <a:t>Thyroiditis, Hypophysitis</a:t>
                      </a:r>
                    </a:p>
                  </a:txBody>
                  <a:tcPr marL="66675" marR="66675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8735535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dirty="0">
                          <a:effectLst/>
                        </a:rPr>
                        <a:t>Rheumatologic or Musculoskeletal (RHEUM/MSK)</a:t>
                      </a:r>
                    </a:p>
                  </a:txBody>
                  <a:tcPr marL="66675" marR="66675" anchor="ctr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</a:rPr>
                        <a:t>Inflammatory Arthritis, PMR</a:t>
                      </a:r>
                    </a:p>
                  </a:txBody>
                  <a:tcPr marL="66675" marR="66675"/>
                </a:tc>
                <a:extLst>
                  <a:ext uri="{0D108BD9-81ED-4DB2-BD59-A6C34878D82A}">
                    <a16:rowId xmlns:a16="http://schemas.microsoft.com/office/drawing/2014/main" val="2872720988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dirty="0">
                          <a:effectLst/>
                        </a:rPr>
                        <a:t>Pulmonary (PULM)</a:t>
                      </a:r>
                    </a:p>
                  </a:txBody>
                  <a:tcPr marL="66675" marR="66675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</a:rPr>
                        <a:t>Pneumonitis</a:t>
                      </a:r>
                    </a:p>
                  </a:txBody>
                  <a:tcPr marL="66675" marR="66675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942685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dirty="0">
                          <a:effectLst/>
                        </a:rPr>
                        <a:t>Neurologic (NEURO)</a:t>
                      </a:r>
                    </a:p>
                  </a:txBody>
                  <a:tcPr marL="66674" marR="66674" anchor="ctr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dirty="0">
                          <a:effectLst/>
                        </a:rPr>
                        <a:t>Uveitis</a:t>
                      </a:r>
                    </a:p>
                  </a:txBody>
                  <a:tcPr marL="66674" marR="66674"/>
                </a:tc>
                <a:extLst>
                  <a:ext uri="{0D108BD9-81ED-4DB2-BD59-A6C34878D82A}">
                    <a16:rowId xmlns:a16="http://schemas.microsoft.com/office/drawing/2014/main" val="2649956511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dirty="0">
                          <a:effectLst/>
                        </a:rPr>
                        <a:t>Renal (RENAL)</a:t>
                      </a:r>
                    </a:p>
                  </a:txBody>
                  <a:tcPr marL="66674" marR="66674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dirty="0">
                          <a:effectLst/>
                        </a:rPr>
                        <a:t>Encephalitis, myelitis, periphreal neuropathy</a:t>
                      </a:r>
                    </a:p>
                  </a:txBody>
                  <a:tcPr marL="66674" marR="66674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986814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u="none" strike="noStrike" noProof="0" dirty="0">
                          <a:solidFill>
                            <a:srgbClr val="000000"/>
                          </a:solidFill>
                          <a:effectLst/>
                        </a:rPr>
                        <a:t>Ophthalmologic (OPHTHL) </a:t>
                      </a:r>
                      <a:endParaRPr lang="en-US" sz="900" dirty="0"/>
                    </a:p>
                  </a:txBody>
                  <a:tcPr marL="66674" marR="66674" anchor="ctr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dirty="0">
                          <a:effectLst/>
                        </a:rPr>
                        <a:t>AIN, podocytopathy</a:t>
                      </a:r>
                    </a:p>
                  </a:txBody>
                  <a:tcPr marL="66674" marR="66674"/>
                </a:tc>
                <a:extLst>
                  <a:ext uri="{0D108BD9-81ED-4DB2-BD59-A6C34878D82A}">
                    <a16:rowId xmlns:a16="http://schemas.microsoft.com/office/drawing/2014/main" val="3716401150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u="none" strike="noStrike" noProof="0" dirty="0">
                          <a:solidFill>
                            <a:srgbClr val="000000"/>
                          </a:solidFill>
                          <a:effectLst/>
                        </a:rPr>
                        <a:t>IV Infusion Reactions</a:t>
                      </a:r>
                      <a:endParaRPr lang="en-US" sz="900" dirty="0">
                        <a:effectLst/>
                      </a:endParaRPr>
                    </a:p>
                  </a:txBody>
                  <a:tcPr marL="66675" marR="66675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</a:rPr>
                        <a:t>Anaphylaxis, Hives</a:t>
                      </a:r>
                    </a:p>
                  </a:txBody>
                  <a:tcPr marL="66675" marR="66675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0310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576599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8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nningham, Michael Montana</dc:creator>
  <cp:lastModifiedBy>MDPI</cp:lastModifiedBy>
  <cp:revision>2</cp:revision>
  <dcterms:created xsi:type="dcterms:W3CDTF">2025-06-16T16:53:33Z</dcterms:created>
  <dcterms:modified xsi:type="dcterms:W3CDTF">2025-06-17T03:51:35Z</dcterms:modified>
</cp:coreProperties>
</file>